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55286-D3A8-4526-B502-F498260B00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D7DBD-FD79-42B2-83EF-61D2BFA69E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5B140A-CB30-489D-8C5F-F32C8C2129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559AA-A413-464E-9BE9-02C109FC19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06DDB-7DC0-48A5-B7EF-1BDE0B0BE9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555C4-F13B-4D7A-8D4F-AE623365E7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4EDD8-446B-44B2-B045-3EBF9D3563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011F5-188A-4D2F-979C-910A705223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20AE3-B7A9-4346-8B07-A7956D0307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F76FB1-B7EE-46FA-9B48-418105A2C0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15392-5FE4-4B30-8833-1698EF0F7B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D173A-6115-41B5-98C8-48B5D5D692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27F09E-5EA9-49FE-B692-4818FAD1090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2"/>
          <p:cNvSpPr/>
          <p:nvPr/>
        </p:nvSpPr>
        <p:spPr>
          <a:xfrm>
            <a:off x="381240" y="304920"/>
            <a:ext cx="2405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ddition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l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1: Tabl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12840" y="685800"/>
          <a:ext cx="6248160" cy="2554200"/>
        </p:xfrm>
        <a:graphic>
          <a:graphicData uri="http://schemas.openxmlformats.org/drawingml/2006/table">
            <a:tbl>
              <a:tblPr/>
              <a:tblGrid>
                <a:gridCol w="1136520"/>
                <a:gridCol w="566640"/>
                <a:gridCol w="568440"/>
                <a:gridCol w="568440"/>
                <a:gridCol w="568080"/>
                <a:gridCol w="568440"/>
                <a:gridCol w="568440"/>
                <a:gridCol w="566640"/>
                <a:gridCol w="568440"/>
                <a:gridCol w="568080"/>
              </a:tblGrid>
              <a:tr h="3427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line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ll1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ll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ll4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L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217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F-10a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BL-100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-MB 43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-MB 45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275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DA-MB 468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W-61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47D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F-7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  <a:tr h="21996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LER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eac5c4"/>
                    </a:solidFill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+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c5d5e9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MAMMY</cp:lastModifiedBy>
  <dcterms:modified xsi:type="dcterms:W3CDTF">2009-08-15T04:37:39Z</dcterms:modified>
  <cp:revision>301</cp:revision>
  <dc:subject/>
  <dc:title>Slide 1</dc:title>
</cp:coreProperties>
</file>